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7" r:id="rId2"/>
    <p:sldId id="256" r:id="rId3"/>
  </p:sldIdLst>
  <p:sldSz cx="17610138" cy="990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3" d="100"/>
          <a:sy n="73" d="100"/>
        </p:scale>
        <p:origin x="67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01267" y="1621191"/>
            <a:ext cx="13207604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01267" y="5202944"/>
            <a:ext cx="13207604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5A093-1065-4808-8477-A88FF66B5BD0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9103A-0871-4333-A780-ECCCCFB780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25587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5A093-1065-4808-8477-A88FF66B5BD0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9103A-0871-4333-A780-ECCCCFB780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08687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602255" y="527403"/>
            <a:ext cx="379718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10697" y="527403"/>
            <a:ext cx="11171431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5A093-1065-4808-8477-A88FF66B5BD0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9103A-0871-4333-A780-ECCCCFB780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1435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5A093-1065-4808-8477-A88FF66B5BD0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9103A-0871-4333-A780-ECCCCFB780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5735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01525" y="2469622"/>
            <a:ext cx="15188744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01525" y="6629225"/>
            <a:ext cx="15188744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5A093-1065-4808-8477-A88FF66B5BD0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9103A-0871-4333-A780-ECCCCFB780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31643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10697" y="2637014"/>
            <a:ext cx="7484309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915132" y="2637014"/>
            <a:ext cx="7484309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5A093-1065-4808-8477-A88FF66B5BD0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9103A-0871-4333-A780-ECCCCFB780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5400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1" y="527404"/>
            <a:ext cx="15188744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12991" y="2428347"/>
            <a:ext cx="744991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12991" y="3618442"/>
            <a:ext cx="744991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915133" y="2428347"/>
            <a:ext cx="7486602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915133" y="3618442"/>
            <a:ext cx="7486602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5A093-1065-4808-8477-A88FF66B5BD0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9103A-0871-4333-A780-ECCCCFB780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7509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5A093-1065-4808-8477-A88FF66B5BD0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9103A-0871-4333-A780-ECCCCFB780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589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5A093-1065-4808-8477-A88FF66B5BD0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9103A-0871-4333-A780-ECCCCFB780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48116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2" y="660400"/>
            <a:ext cx="5679727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486603" y="1426281"/>
            <a:ext cx="8915132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12992" y="2971800"/>
            <a:ext cx="5679727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5A093-1065-4808-8477-A88FF66B5BD0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9103A-0871-4333-A780-ECCCCFB780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8424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2" y="660400"/>
            <a:ext cx="5679727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486603" y="1426281"/>
            <a:ext cx="8915132" cy="7039681"/>
          </a:xfrm>
        </p:spPr>
        <p:txBody>
          <a:bodyPr anchor="t"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12992" y="2971800"/>
            <a:ext cx="5679727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5A093-1065-4808-8477-A88FF66B5BD0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9103A-0871-4333-A780-ECCCCFB780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655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10697" y="527404"/>
            <a:ext cx="15188744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10697" y="2637014"/>
            <a:ext cx="15188744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10697" y="9181395"/>
            <a:ext cx="3962281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55A093-1065-4808-8477-A88FF66B5BD0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833358" y="9181395"/>
            <a:ext cx="5943422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437160" y="9181395"/>
            <a:ext cx="3962281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19103A-0871-4333-A780-ECCCCFB780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47364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tiff"/><Relationship Id="rId13" Type="http://schemas.openxmlformats.org/officeDocument/2006/relationships/image" Target="../media/image24.tiff"/><Relationship Id="rId3" Type="http://schemas.openxmlformats.org/officeDocument/2006/relationships/image" Target="../media/image14.tiff"/><Relationship Id="rId7" Type="http://schemas.openxmlformats.org/officeDocument/2006/relationships/image" Target="../media/image18.tiff"/><Relationship Id="rId12" Type="http://schemas.openxmlformats.org/officeDocument/2006/relationships/image" Target="../media/image23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tiff"/><Relationship Id="rId11" Type="http://schemas.openxmlformats.org/officeDocument/2006/relationships/image" Target="../media/image22.tiff"/><Relationship Id="rId5" Type="http://schemas.openxmlformats.org/officeDocument/2006/relationships/image" Target="../media/image16.tiff"/><Relationship Id="rId10" Type="http://schemas.openxmlformats.org/officeDocument/2006/relationships/image" Target="../media/image21.tiff"/><Relationship Id="rId4" Type="http://schemas.openxmlformats.org/officeDocument/2006/relationships/image" Target="../media/image15.tiff"/><Relationship Id="rId9" Type="http://schemas.openxmlformats.org/officeDocument/2006/relationships/image" Target="../media/image2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/>
          <p:cNvSpPr txBox="1"/>
          <p:nvPr/>
        </p:nvSpPr>
        <p:spPr>
          <a:xfrm>
            <a:off x="6252372" y="769858"/>
            <a:ext cx="19526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</a:t>
            </a:r>
            <a:r>
              <a:rPr lang="en-US" dirty="0"/>
              <a:t>-endorphin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8715488" y="769858"/>
            <a:ext cx="19526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-</a:t>
            </a:r>
            <a:r>
              <a:rPr lang="en-US" dirty="0" err="1"/>
              <a:t>fos</a:t>
            </a:r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10753838" y="769858"/>
            <a:ext cx="19526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erge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0296" y="1143000"/>
            <a:ext cx="2080612" cy="155448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50119" y="1144198"/>
            <a:ext cx="2080612" cy="1554480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50208" y="1144198"/>
            <a:ext cx="2080612" cy="1554480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0296" y="2718435"/>
            <a:ext cx="2080612" cy="1554480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50119" y="2718435"/>
            <a:ext cx="2080612" cy="1554480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50207" y="2718435"/>
            <a:ext cx="2080612" cy="1554480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0296" y="4292672"/>
            <a:ext cx="2080612" cy="1554480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50119" y="4292672"/>
            <a:ext cx="2080612" cy="1554480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50208" y="4292672"/>
            <a:ext cx="2080612" cy="1554480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0296" y="5866909"/>
            <a:ext cx="2080612" cy="1554480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50119" y="5866909"/>
            <a:ext cx="2080612" cy="1554480"/>
          </a:xfrm>
          <a:prstGeom prst="rect">
            <a:avLst/>
          </a:prstGeom>
        </p:spPr>
      </p:pic>
      <p:pic>
        <p:nvPicPr>
          <p:cNvPr id="32" name="Picture 31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50207" y="5866909"/>
            <a:ext cx="2080612" cy="1554480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>
            <a:off x="5850299" y="306266"/>
            <a:ext cx="12212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Female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371E6A7-7034-DF46-8A4D-4D681E0E3693}"/>
              </a:ext>
            </a:extLst>
          </p:cNvPr>
          <p:cNvSpPr txBox="1"/>
          <p:nvPr/>
        </p:nvSpPr>
        <p:spPr>
          <a:xfrm>
            <a:off x="4611759" y="1743164"/>
            <a:ext cx="13544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WT+Salin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BAF779A-646D-9350-FFEA-54A0D2E389D2}"/>
              </a:ext>
            </a:extLst>
          </p:cNvPr>
          <p:cNvSpPr txBox="1"/>
          <p:nvPr/>
        </p:nvSpPr>
        <p:spPr>
          <a:xfrm>
            <a:off x="4036384" y="3293735"/>
            <a:ext cx="20806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WT +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Lorcaser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705A90C-7915-484A-C4B6-891358A73917}"/>
              </a:ext>
            </a:extLst>
          </p:cNvPr>
          <p:cNvSpPr txBox="1"/>
          <p:nvPr/>
        </p:nvSpPr>
        <p:spPr>
          <a:xfrm>
            <a:off x="3236600" y="6449332"/>
            <a:ext cx="25943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0" i="1" u="none" strike="noStrike" dirty="0">
                <a:latin typeface="Arial-ItalicMT"/>
              </a:rPr>
              <a:t>Htr2c</a:t>
            </a:r>
            <a:r>
              <a:rPr lang="en-US" b="0" i="1" u="none" strike="noStrike" baseline="30000" dirty="0">
                <a:latin typeface="Arial-ItalicMT"/>
              </a:rPr>
              <a:t>F327L/+</a:t>
            </a:r>
            <a:r>
              <a:rPr lang="en-US" b="0" i="1" u="none" strike="noStrike" dirty="0">
                <a:latin typeface="Arial-ItalicMT"/>
              </a:rPr>
              <a:t>+ </a:t>
            </a:r>
            <a:r>
              <a:rPr lang="en-US" b="0" u="none" strike="noStrike" dirty="0" err="1">
                <a:latin typeface="Arial-ItalicMT"/>
              </a:rPr>
              <a:t>Lorcaserin</a:t>
            </a:r>
            <a:endParaRPr lang="en-US" baseline="300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8F9D6B3-AE65-F890-6603-515B678E5DC6}"/>
              </a:ext>
            </a:extLst>
          </p:cNvPr>
          <p:cNvSpPr txBox="1"/>
          <p:nvPr/>
        </p:nvSpPr>
        <p:spPr>
          <a:xfrm>
            <a:off x="3748862" y="4856581"/>
            <a:ext cx="22681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0" i="1" u="none" strike="noStrike" dirty="0">
                <a:latin typeface="Arial-ItalicMT"/>
              </a:rPr>
              <a:t>Htr2c</a:t>
            </a:r>
            <a:r>
              <a:rPr lang="en-US" b="0" i="1" u="none" strike="noStrike" baseline="30000" dirty="0">
                <a:latin typeface="Arial-ItalicMT"/>
              </a:rPr>
              <a:t>F327L/+</a:t>
            </a:r>
            <a:r>
              <a:rPr lang="en-US" b="0" i="1" u="none" strike="noStrike" dirty="0">
                <a:latin typeface="Arial-ItalicMT"/>
              </a:rPr>
              <a:t>+ </a:t>
            </a:r>
            <a:r>
              <a:rPr lang="en-US" b="0" u="none" strike="noStrike" dirty="0">
                <a:latin typeface="Arial-ItalicMT"/>
              </a:rPr>
              <a:t>Saline</a:t>
            </a:r>
            <a:endParaRPr lang="en-US" baseline="30000" dirty="0"/>
          </a:p>
        </p:txBody>
      </p:sp>
    </p:spTree>
    <p:extLst>
      <p:ext uri="{BB962C8B-B14F-4D97-AF65-F5344CB8AC3E}">
        <p14:creationId xmlns:p14="http://schemas.microsoft.com/office/powerpoint/2010/main" val="26413224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50212" y="1139190"/>
            <a:ext cx="2080611" cy="155448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50123" y="1139190"/>
            <a:ext cx="2080611" cy="155448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0301" y="1139190"/>
            <a:ext cx="2080611" cy="155448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50208" y="2718435"/>
            <a:ext cx="2080612" cy="155448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50120" y="2718435"/>
            <a:ext cx="2080612" cy="155448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0296" y="2718435"/>
            <a:ext cx="2080612" cy="155448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0296" y="4293870"/>
            <a:ext cx="2080612" cy="155448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50208" y="4293870"/>
            <a:ext cx="2080612" cy="155448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50120" y="4293870"/>
            <a:ext cx="2080612" cy="155448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50208" y="5869305"/>
            <a:ext cx="2080612" cy="1554480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50119" y="5869305"/>
            <a:ext cx="2080612" cy="155448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0296" y="5869305"/>
            <a:ext cx="2080612" cy="155448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6252372" y="769858"/>
            <a:ext cx="19526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</a:t>
            </a:r>
            <a:r>
              <a:rPr lang="en-US" dirty="0"/>
              <a:t>-endorphin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8715488" y="769858"/>
            <a:ext cx="19526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-</a:t>
            </a:r>
            <a:r>
              <a:rPr lang="en-US" dirty="0" err="1"/>
              <a:t>fos</a:t>
            </a:r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10753838" y="769858"/>
            <a:ext cx="19526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erge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611759" y="1743164"/>
            <a:ext cx="13544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WT+Salin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036384" y="3293735"/>
            <a:ext cx="20806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WT +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Lorcaser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5850299" y="304800"/>
            <a:ext cx="12212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Mal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5E26C9E-0B33-B522-E54E-238C34D76FA5}"/>
              </a:ext>
            </a:extLst>
          </p:cNvPr>
          <p:cNvSpPr txBox="1"/>
          <p:nvPr/>
        </p:nvSpPr>
        <p:spPr>
          <a:xfrm>
            <a:off x="3236600" y="6449332"/>
            <a:ext cx="25943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0" i="1" u="none" strike="noStrike" dirty="0">
                <a:latin typeface="Arial-ItalicMT"/>
              </a:rPr>
              <a:t>Htr2c</a:t>
            </a:r>
            <a:r>
              <a:rPr lang="en-US" b="0" i="1" u="none" strike="noStrike" baseline="30000" dirty="0">
                <a:latin typeface="Arial-ItalicMT"/>
              </a:rPr>
              <a:t>F327L/Y</a:t>
            </a:r>
            <a:r>
              <a:rPr lang="en-US" b="0" i="1" u="none" strike="noStrike" dirty="0">
                <a:latin typeface="Arial-ItalicMT"/>
              </a:rPr>
              <a:t>+ </a:t>
            </a:r>
            <a:r>
              <a:rPr lang="en-US" b="0" u="none" strike="noStrike" dirty="0" err="1">
                <a:latin typeface="Arial-ItalicMT"/>
              </a:rPr>
              <a:t>Lorcaserin</a:t>
            </a:r>
            <a:endParaRPr lang="en-US" baseline="300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5DCFF38-1D09-FD65-467B-4A44A90D0609}"/>
              </a:ext>
            </a:extLst>
          </p:cNvPr>
          <p:cNvSpPr txBox="1"/>
          <p:nvPr/>
        </p:nvSpPr>
        <p:spPr>
          <a:xfrm>
            <a:off x="3748862" y="4856581"/>
            <a:ext cx="22681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0" i="1" u="none" strike="noStrike" dirty="0">
                <a:latin typeface="Arial-ItalicMT"/>
              </a:rPr>
              <a:t>Htr2c</a:t>
            </a:r>
            <a:r>
              <a:rPr lang="en-US" b="0" i="1" u="none" strike="noStrike" baseline="30000" dirty="0">
                <a:latin typeface="Arial-ItalicMT"/>
              </a:rPr>
              <a:t>F327L/Y</a:t>
            </a:r>
            <a:r>
              <a:rPr lang="en-US" b="0" i="1" u="none" strike="noStrike" dirty="0">
                <a:latin typeface="Arial-ItalicMT"/>
              </a:rPr>
              <a:t>+ </a:t>
            </a:r>
            <a:r>
              <a:rPr lang="en-US" b="0" u="none" strike="noStrike" dirty="0">
                <a:latin typeface="Arial-ItalicMT"/>
              </a:rPr>
              <a:t>Saline</a:t>
            </a:r>
            <a:endParaRPr lang="en-US" baseline="30000" dirty="0"/>
          </a:p>
        </p:txBody>
      </p:sp>
    </p:spTree>
    <p:extLst>
      <p:ext uri="{BB962C8B-B14F-4D97-AF65-F5344CB8AC3E}">
        <p14:creationId xmlns:p14="http://schemas.microsoft.com/office/powerpoint/2010/main" val="23348476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</TotalTime>
  <Words>36</Words>
  <Application>Microsoft Office PowerPoint</Application>
  <PresentationFormat>Custom</PresentationFormat>
  <Paragraphs>1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Arial-ItalicMT</vt:lpstr>
      <vt:lpstr>Calibri</vt:lpstr>
      <vt:lpstr>Calibri Light</vt:lpstr>
      <vt:lpstr>Office Theme</vt:lpstr>
      <vt:lpstr>PowerPoint Presentation</vt:lpstr>
      <vt:lpstr>PowerPoint Presentation</vt:lpstr>
    </vt:vector>
  </TitlesOfParts>
  <Company>Baylor College of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u, Hailan</dc:creator>
  <cp:lastModifiedBy>Sadaf Farooqi</cp:lastModifiedBy>
  <cp:revision>7</cp:revision>
  <dcterms:created xsi:type="dcterms:W3CDTF">2022-07-09T04:10:57Z</dcterms:created>
  <dcterms:modified xsi:type="dcterms:W3CDTF">2022-10-21T13:32:54Z</dcterms:modified>
</cp:coreProperties>
</file>